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61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66" d="100"/>
          <a:sy n="66" d="100"/>
        </p:scale>
        <p:origin x="-1422" y="-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414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8DC5F7-0DD1-474C-A0AC-BD4CA7234442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7C6FC7-FAB9-4B44-A9B8-73815F36486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1: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he 5' and the 3' end amplifications of crossbred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mRNA using RLM-RACE methodology. A) 5’ RLM-RACE PCR (5RI) has shown a band of ~190 bp. 5’ gene-specific PCR (5’GSP) was run as a positive control, and negative TAP was run to see amplification from degraded or incomplete BBD129 mRNA. 100bp = 100 base pair DNA ladder, 50bp = 50 base pair DNA ladder.</a:t>
            </a:r>
          </a:p>
          <a:p>
            <a:r>
              <a:rPr lang="en-US" dirty="0" smtClean="0"/>
              <a:t>* Lane numbers 5 to 7 are not of</a:t>
            </a:r>
            <a:r>
              <a:rPr lang="en-US" baseline="0" dirty="0" smtClean="0"/>
              <a:t> our interest, Lane5= non-specific PCR product, Lane6=empty, Lane7= 100bp DNA ladder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7C6FC7-FAB9-4B44-A9B8-73815F364864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1: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he 5' and the 3' end amplifications of crossbred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mRNA using RLM-RACE methodology. 1B) The 3’ RACE PCR (3RI) has a band of ~300 bp. Glyceraldehyde 3-phosphate dehydrogenase (GAP) and Non template control (NTC) were run as positive and negative PCR control, respectively. 100bp = 100 base pair DNA ladder, 50bp = 50 base pair DNA ladder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*Lanes 6 to 8 are empty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7C6FC7-FAB9-4B44-A9B8-73815F364864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5: 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genomic DNA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os indicus x Bos taurus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gene. A) The genomic DNA PCR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exon-1 from distinct fertility cross-bred bulls. B The genomic DNA PCR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exon-2 has shown a band around 500bp in the high fertile cross-bred bulls. C) The genomic DNA PCR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exon-2 has shown a band around 500bp in the low fertile cross-bred bulls Abbreviations: HF = High fertile crossbred bull, LF = Low fertile crossbred bull.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*</a:t>
            </a:r>
            <a:r>
              <a:rPr lang="en-US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Side wells are empty</a:t>
            </a:r>
            <a:endParaRPr lang="en-US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7C6FC7-FAB9-4B44-A9B8-73815F364864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5: 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genomic DNA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os indicus x Bos taurus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gene. A) The genomic DNA PCR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exon-1 from distinct fertility cross-bred bulls. B The genomic DNA PCR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exon-2 has shown a band around 500bp in the high fertile cross-bred bulls. C) The genomic DNA PCR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exon-2 has shown a band around 500bp in the low fertile cross-bred bulls Abbreviations: HF = High fertile crossbred bull, LF = Low fertile crossbred bull.</a:t>
            </a:r>
          </a:p>
          <a:p>
            <a:r>
              <a:rPr lang="en-US" b="1" dirty="0" smtClean="0"/>
              <a:t>* </a:t>
            </a:r>
            <a:r>
              <a:rPr lang="en-US" b="0" dirty="0" smtClean="0"/>
              <a:t>Last</a:t>
            </a:r>
            <a:r>
              <a:rPr lang="en-US" b="0" baseline="0" dirty="0" smtClean="0"/>
              <a:t> well is empty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7C6FC7-FAB9-4B44-A9B8-73815F364864}" type="slidenum">
              <a:rPr lang="en-US" smtClean="0"/>
              <a:pPr/>
              <a:t>4</a:t>
            </a:fld>
            <a:endParaRPr 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5: 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he genomic DNA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os indicus x Bos taurus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gene. A) The genomic DNA PCR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exon-1 from distinct fertility cross-bred bulls. B The genomic DNA PCR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exon-2 has shown a band around 500bp in the high fertile cross-bred bulls. C) The genomic DNA PCR amplification of </a:t>
            </a:r>
            <a:r>
              <a:rPr lang="en-US" sz="1200" i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BD129</a:t>
            </a:r>
            <a:r>
              <a:rPr lang="en-US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 exon-2 has shown a band around 500bp in the low fertile cross-bred bulls Abbreviations: HF = High fertile crossbred bull, LF = Low fertile crossbred bull.</a:t>
            </a:r>
          </a:p>
          <a:p>
            <a:r>
              <a:rPr lang="en-US" dirty="0" smtClean="0"/>
              <a:t>* Last well was not of</a:t>
            </a:r>
            <a:r>
              <a:rPr lang="en-US" baseline="0" dirty="0" smtClean="0"/>
              <a:t> any interest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7C6FC7-FAB9-4B44-A9B8-73815F364864}" type="slidenum">
              <a:rPr lang="en-US" smtClean="0"/>
              <a:pPr/>
              <a:t>5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9D74C1-0937-4434-A667-F04C5BB9A40F}" type="datetimeFigureOut">
              <a:rPr lang="en-US" smtClean="0"/>
              <a:pPr/>
              <a:t>6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E939A-781D-4E4E-B7C6-4728D700639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0"/>
          <p:cNvGrpSpPr/>
          <p:nvPr/>
        </p:nvGrpSpPr>
        <p:grpSpPr>
          <a:xfrm>
            <a:off x="357158" y="214290"/>
            <a:ext cx="8572560" cy="5772152"/>
            <a:chOff x="357158" y="285728"/>
            <a:chExt cx="6689367" cy="5486400"/>
          </a:xfrm>
        </p:grpSpPr>
        <p:pic>
          <p:nvPicPr>
            <p:cNvPr id="16" name="Picture 1" descr="E:\PhD\phd\Mr. SS\1st Objective\DEF129 RACE\KF 129 RACE\final products\HP 2021-03-07 16hr 21min KF BBD129 RACE 100BP 5RI 5GSP -TAP 3RI NTC 100BP..jpg"/>
            <p:cNvPicPr>
              <a:picLocks noChangeAspect="1" noChangeArrowheads="1"/>
            </p:cNvPicPr>
            <p:nvPr/>
          </p:nvPicPr>
          <p:blipFill>
            <a:blip r:embed="rId3"/>
            <a:srcRect l="12416" t="3675" r="22212" b="3282"/>
            <a:stretch>
              <a:fillRect/>
            </a:stretch>
          </p:blipFill>
          <p:spPr bwMode="auto">
            <a:xfrm>
              <a:off x="940342" y="285728"/>
              <a:ext cx="6106183" cy="5486400"/>
            </a:xfrm>
            <a:prstGeom prst="rect">
              <a:avLst/>
            </a:prstGeom>
            <a:noFill/>
          </p:spPr>
        </p:pic>
        <p:sp>
          <p:nvSpPr>
            <p:cNvPr id="17" name="TextBox 16"/>
            <p:cNvSpPr txBox="1"/>
            <p:nvPr/>
          </p:nvSpPr>
          <p:spPr>
            <a:xfrm>
              <a:off x="1108011" y="285728"/>
              <a:ext cx="5870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200" b="1" dirty="0" smtClean="0">
                  <a:solidFill>
                    <a:schemeClr val="bg1"/>
                  </a:solidFill>
                </a:rPr>
                <a:t>100bp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021126" y="285728"/>
              <a:ext cx="5100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200" b="1" dirty="0" smtClean="0">
                  <a:solidFill>
                    <a:schemeClr val="bg1"/>
                  </a:solidFill>
                </a:rPr>
                <a:t>5’5RI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873416" y="285728"/>
              <a:ext cx="549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200" b="1" dirty="0" smtClean="0">
                  <a:solidFill>
                    <a:schemeClr val="bg1"/>
                  </a:solidFill>
                </a:rPr>
                <a:t>5’GSP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724285" y="285728"/>
              <a:ext cx="4707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sz="1200" b="1" dirty="0" smtClean="0">
                  <a:solidFill>
                    <a:schemeClr val="bg1"/>
                  </a:solidFill>
                </a:rPr>
                <a:t>-TAP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57158" y="1928803"/>
              <a:ext cx="928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/>
                <a:t>300bp</a:t>
              </a:r>
              <a:endParaRPr lang="en-US" sz="12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57158" y="2857496"/>
              <a:ext cx="7858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/>
                <a:t>100bp</a:t>
              </a:r>
              <a:endParaRPr lang="en-US" sz="12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57158" y="2331929"/>
              <a:ext cx="7143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/>
                <a:t>200bp</a:t>
              </a:r>
              <a:endParaRPr lang="en-US" sz="12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57158" y="1714489"/>
              <a:ext cx="7858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/>
                <a:t>400bp</a:t>
              </a:r>
              <a:endParaRPr lang="en-US" sz="12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57158" y="1555094"/>
              <a:ext cx="6233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 smtClean="0"/>
                <a:t>500bp</a:t>
              </a:r>
              <a:endParaRPr lang="en-US" sz="1200" b="1" dirty="0"/>
            </a:p>
          </p:txBody>
        </p:sp>
      </p:grpSp>
      <p:sp>
        <p:nvSpPr>
          <p:cNvPr id="48" name="TextBox 47"/>
          <p:cNvSpPr txBox="1"/>
          <p:nvPr/>
        </p:nvSpPr>
        <p:spPr>
          <a:xfrm>
            <a:off x="214282" y="214290"/>
            <a:ext cx="8620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Figure 1</a:t>
            </a:r>
            <a:endParaRPr lang="en-US" sz="16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857224" y="500042"/>
            <a:ext cx="7286675" cy="6143668"/>
            <a:chOff x="214282" y="214290"/>
            <a:chExt cx="7286675" cy="6143668"/>
          </a:xfrm>
        </p:grpSpPr>
        <p:grpSp>
          <p:nvGrpSpPr>
            <p:cNvPr id="22" name="Group 21"/>
            <p:cNvGrpSpPr/>
            <p:nvPr/>
          </p:nvGrpSpPr>
          <p:grpSpPr>
            <a:xfrm>
              <a:off x="1357290" y="500042"/>
              <a:ext cx="6143667" cy="5857916"/>
              <a:chOff x="642910" y="214290"/>
              <a:chExt cx="4714907" cy="5857916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642910" y="214290"/>
                <a:ext cx="4714907" cy="5857916"/>
                <a:chOff x="2786050" y="214290"/>
                <a:chExt cx="4714907" cy="5857916"/>
              </a:xfrm>
            </p:grpSpPr>
            <p:pic>
              <p:nvPicPr>
                <p:cNvPr id="10" name="Picture 2" descr="E:\PhD\phd\Mr. SS\2nd Objective\gel dock data subhash\gel doc PHOTO files\KF BBD129 50BP 3RI GAP NTC 100BP.jpg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 l="7405" r="11620" b="-1235"/>
                <a:stretch>
                  <a:fillRect/>
                </a:stretch>
              </p:blipFill>
              <p:spPr bwMode="auto">
                <a:xfrm>
                  <a:off x="2786050" y="214290"/>
                  <a:ext cx="4714907" cy="5857916"/>
                </a:xfrm>
                <a:prstGeom prst="rect">
                  <a:avLst/>
                </a:prstGeom>
                <a:noFill/>
              </p:spPr>
            </p:pic>
            <p:sp>
              <p:nvSpPr>
                <p:cNvPr id="11" name="TextBox 10"/>
                <p:cNvSpPr txBox="1"/>
                <p:nvPr/>
              </p:nvSpPr>
              <p:spPr>
                <a:xfrm>
                  <a:off x="3057009" y="214290"/>
                  <a:ext cx="402617" cy="2921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just"/>
                  <a:r>
                    <a:rPr lang="en-US" sz="1200" b="1" dirty="0" smtClean="0">
                      <a:solidFill>
                        <a:schemeClr val="bg1"/>
                      </a:solidFill>
                    </a:rPr>
                    <a:t>50bp</a:t>
                  </a:r>
                  <a:endParaRPr lang="en-US" sz="1200" b="1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3509535" y="214290"/>
                  <a:ext cx="341691" cy="2921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just"/>
                  <a:r>
                    <a:rPr lang="en-US" sz="1200" b="1" dirty="0" smtClean="0">
                      <a:solidFill>
                        <a:schemeClr val="bg1"/>
                      </a:solidFill>
                    </a:rPr>
                    <a:t>3’RI</a:t>
                  </a:r>
                  <a:endParaRPr lang="en-US" sz="1200" b="1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4018627" y="214290"/>
                  <a:ext cx="361999" cy="2921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just"/>
                  <a:r>
                    <a:rPr lang="en-US" sz="1200" b="1" dirty="0" smtClean="0">
                      <a:solidFill>
                        <a:schemeClr val="bg1"/>
                      </a:solidFill>
                    </a:rPr>
                    <a:t>GAP</a:t>
                  </a:r>
                  <a:endParaRPr lang="en-US" sz="1200" b="1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4584284" y="214290"/>
                  <a:ext cx="349155" cy="2921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just"/>
                  <a:r>
                    <a:rPr lang="en-US" sz="1200" b="1" dirty="0" smtClean="0">
                      <a:solidFill>
                        <a:schemeClr val="bg1"/>
                      </a:solidFill>
                    </a:rPr>
                    <a:t>NTC</a:t>
                  </a:r>
                  <a:endParaRPr lang="en-US" sz="1200" b="1" dirty="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5036810" y="214290"/>
                  <a:ext cx="464812" cy="29214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just"/>
                  <a:r>
                    <a:rPr lang="en-US" sz="1200" b="1" dirty="0" smtClean="0">
                      <a:solidFill>
                        <a:schemeClr val="bg1"/>
                      </a:solidFill>
                    </a:rPr>
                    <a:t>100bp</a:t>
                  </a:r>
                  <a:endParaRPr lang="en-US" sz="1200" b="1" dirty="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17" name="TextBox 16"/>
              <p:cNvSpPr txBox="1"/>
              <p:nvPr/>
            </p:nvSpPr>
            <p:spPr>
              <a:xfrm>
                <a:off x="3511747" y="4242422"/>
                <a:ext cx="8202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 smtClean="0">
                    <a:solidFill>
                      <a:schemeClr val="bg1"/>
                    </a:solidFill>
                  </a:rPr>
                  <a:t>300bp</a:t>
                </a:r>
                <a:endParaRPr lang="en-US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511747" y="4937951"/>
                <a:ext cx="8202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 smtClean="0">
                    <a:solidFill>
                      <a:schemeClr val="bg1"/>
                    </a:solidFill>
                  </a:rPr>
                  <a:t>100bp</a:t>
                </a:r>
                <a:endParaRPr lang="en-US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515514" y="4561224"/>
                <a:ext cx="8202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 smtClean="0">
                    <a:solidFill>
                      <a:schemeClr val="bg1"/>
                    </a:solidFill>
                  </a:rPr>
                  <a:t>200bp</a:t>
                </a:r>
                <a:endParaRPr lang="en-US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3515514" y="3941040"/>
                <a:ext cx="8202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 smtClean="0">
                    <a:solidFill>
                      <a:schemeClr val="bg1"/>
                    </a:solidFill>
                  </a:rPr>
                  <a:t>400bp</a:t>
                </a:r>
                <a:endParaRPr lang="en-US" sz="12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500430" y="3715005"/>
                <a:ext cx="82021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 smtClean="0">
                    <a:solidFill>
                      <a:schemeClr val="bg1"/>
                    </a:solidFill>
                  </a:rPr>
                  <a:t>500bp</a:t>
                </a:r>
                <a:endParaRPr lang="en-US" sz="1200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214282" y="214290"/>
              <a:ext cx="86203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Figure 1</a:t>
              </a:r>
              <a:endParaRPr lang="en-US" sz="1600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8"/>
          <p:cNvGrpSpPr/>
          <p:nvPr/>
        </p:nvGrpSpPr>
        <p:grpSpPr>
          <a:xfrm>
            <a:off x="571472" y="1500174"/>
            <a:ext cx="8001024" cy="4214818"/>
            <a:chOff x="716419" y="1214422"/>
            <a:chExt cx="9601239" cy="5366024"/>
          </a:xfrm>
        </p:grpSpPr>
        <p:grpSp>
          <p:nvGrpSpPr>
            <p:cNvPr id="3" name="Group 17"/>
            <p:cNvGrpSpPr/>
            <p:nvPr/>
          </p:nvGrpSpPr>
          <p:grpSpPr>
            <a:xfrm>
              <a:off x="716419" y="1214422"/>
              <a:ext cx="9601239" cy="5366024"/>
              <a:chOff x="716419" y="1214422"/>
              <a:chExt cx="9601239" cy="5366024"/>
            </a:xfrm>
          </p:grpSpPr>
          <p:pic>
            <p:nvPicPr>
              <p:cNvPr id="1027" name="Picture 3" descr="C:\Users\dell\OneDrive\Desktop\HP 2020-03-17 18hr 10min BBD126E1 KF BULLS 4378 5788 6332 6479 6568 6695 7063 7141 7178 7205 NTC.jpg"/>
              <p:cNvPicPr>
                <a:picLocks noChangeAspect="1" noChangeArrowheads="1"/>
              </p:cNvPicPr>
              <p:nvPr/>
            </p:nvPicPr>
            <p:blipFill>
              <a:blip r:embed="rId3"/>
              <a:srcRect l="-1342" t="5097" r="-1764" b="28061"/>
              <a:stretch>
                <a:fillRect/>
              </a:stretch>
            </p:blipFill>
            <p:spPr bwMode="auto">
              <a:xfrm>
                <a:off x="716419" y="1251057"/>
                <a:ext cx="9601239" cy="5329389"/>
              </a:xfrm>
              <a:prstGeom prst="rect">
                <a:avLst/>
              </a:prstGeom>
              <a:noFill/>
            </p:spPr>
          </p:pic>
          <p:sp>
            <p:nvSpPr>
              <p:cNvPr id="45" name="TextBox 44"/>
              <p:cNvSpPr txBox="1"/>
              <p:nvPr/>
            </p:nvSpPr>
            <p:spPr>
              <a:xfrm>
                <a:off x="4858464" y="1214422"/>
                <a:ext cx="6912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100 bp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1696110" y="1214422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LF1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2242700" y="1214422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LF2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2785276" y="1214422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LF3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3347411" y="1214422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LF4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3875568" y="1227664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LF5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4398086" y="1214422"/>
                <a:ext cx="43313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LF6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5496139" y="1214422"/>
                <a:ext cx="47000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HF1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6059401" y="1214422"/>
                <a:ext cx="47000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HF2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6581919" y="1214422"/>
                <a:ext cx="47000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HF3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7104437" y="1214422"/>
                <a:ext cx="47000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HF4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7692270" y="1214422"/>
                <a:ext cx="47000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>
                    <a:solidFill>
                      <a:schemeClr val="bg1"/>
                    </a:solidFill>
                  </a:rPr>
                  <a:t>HF5</a:t>
                </a:r>
                <a:endParaRPr lang="en-US" sz="1400" b="1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69" name="TextBox 68"/>
            <p:cNvSpPr txBox="1"/>
            <p:nvPr/>
          </p:nvSpPr>
          <p:spPr>
            <a:xfrm>
              <a:off x="5429256" y="3429000"/>
              <a:ext cx="1030784" cy="3918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chemeClr val="bg1"/>
                  </a:solidFill>
                </a:rPr>
                <a:t>200bp</a:t>
              </a:r>
              <a:endParaRPr lang="en-US" sz="14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214282" y="214290"/>
            <a:ext cx="9870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Figure 5A</a:t>
            </a:r>
            <a:endParaRPr lang="en-US" sz="16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22"/>
          <p:cNvGrpSpPr/>
          <p:nvPr/>
        </p:nvGrpSpPr>
        <p:grpSpPr>
          <a:xfrm>
            <a:off x="2285983" y="714356"/>
            <a:ext cx="5786479" cy="5500727"/>
            <a:chOff x="4073547" y="883919"/>
            <a:chExt cx="2432281" cy="3267299"/>
          </a:xfrm>
        </p:grpSpPr>
        <p:pic>
          <p:nvPicPr>
            <p:cNvPr id="17" name="Picture 2" descr="C:\Users\dell\OneDrive\Desktop\HP 2018-08-01 11hr 47min gDNA PCR kf 6332 6479 6555 7178.jpg"/>
            <p:cNvPicPr>
              <a:picLocks noChangeAspect="1" noChangeArrowheads="1"/>
            </p:cNvPicPr>
            <p:nvPr/>
          </p:nvPicPr>
          <p:blipFill>
            <a:blip r:embed="rId3"/>
            <a:srcRect l="-1475" t="-712" r="-3182" b="517"/>
            <a:stretch>
              <a:fillRect/>
            </a:stretch>
          </p:blipFill>
          <p:spPr bwMode="auto">
            <a:xfrm>
              <a:off x="4073547" y="883919"/>
              <a:ext cx="2432281" cy="3267299"/>
            </a:xfrm>
            <a:prstGeom prst="rect">
              <a:avLst/>
            </a:prstGeom>
            <a:noFill/>
          </p:spPr>
        </p:pic>
        <p:sp>
          <p:nvSpPr>
            <p:cNvPr id="18" name="TextBox 17"/>
            <p:cNvSpPr txBox="1"/>
            <p:nvPr/>
          </p:nvSpPr>
          <p:spPr>
            <a:xfrm>
              <a:off x="4275726" y="926351"/>
              <a:ext cx="338328" cy="2010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</a:rPr>
                <a:t>5</a:t>
              </a:r>
              <a:r>
                <a:rPr lang="en-US" sz="1400" b="1" dirty="0" smtClean="0">
                  <a:solidFill>
                    <a:schemeClr val="bg1"/>
                  </a:solidFill>
                </a:rPr>
                <a:t>0 bp</a:t>
              </a:r>
              <a:endParaRPr lang="en-US" sz="1400" b="1" dirty="0">
                <a:solidFill>
                  <a:schemeClr val="bg1"/>
                </a:solidFill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2082662" y="4878907"/>
            <a:ext cx="247879" cy="338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572801" y="4653102"/>
            <a:ext cx="804894" cy="338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5</a:t>
            </a:r>
            <a:r>
              <a:rPr lang="en-US" sz="1400" b="1" dirty="0" smtClean="0"/>
              <a:t>0 bp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572801" y="4157282"/>
            <a:ext cx="927497" cy="338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00 bp</a:t>
            </a:r>
            <a:endParaRPr 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572801" y="3931477"/>
            <a:ext cx="927497" cy="338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50 bp</a:t>
            </a:r>
            <a:endParaRPr 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572801" y="3570664"/>
            <a:ext cx="927497" cy="338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00 bp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572801" y="3315386"/>
            <a:ext cx="927497" cy="338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50 bp</a:t>
            </a:r>
            <a:endParaRPr 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1572801" y="2949885"/>
            <a:ext cx="873724" cy="338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400bp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572801" y="2691199"/>
            <a:ext cx="927497" cy="338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5</a:t>
            </a:r>
            <a:r>
              <a:rPr lang="en-US" sz="1400" b="1" dirty="0" smtClean="0"/>
              <a:t>00 bp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572799" y="2007143"/>
            <a:ext cx="669382" cy="3383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 kb</a:t>
            </a:r>
            <a:endParaRPr lang="en-US" sz="14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3643305" y="714356"/>
            <a:ext cx="630663" cy="3383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HF1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450514" y="738572"/>
            <a:ext cx="630663" cy="3383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HF2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985319" y="738572"/>
            <a:ext cx="630663" cy="3383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HF3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696670" y="714356"/>
            <a:ext cx="630663" cy="3383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HF4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463535" y="714356"/>
            <a:ext cx="630663" cy="3383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HF5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14282" y="214290"/>
            <a:ext cx="9774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Figure 5B</a:t>
            </a:r>
            <a:endParaRPr lang="en-US" sz="1600" b="1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076346" y="4451559"/>
            <a:ext cx="7635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100bp</a:t>
            </a:r>
            <a:endParaRPr 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076346" y="4239825"/>
            <a:ext cx="7635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200bp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076345" y="4035036"/>
            <a:ext cx="8438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300bp</a:t>
            </a:r>
            <a:endParaRPr lang="en-US" sz="1400" b="1" dirty="0"/>
          </a:p>
        </p:txBody>
      </p:sp>
      <p:sp>
        <p:nvSpPr>
          <p:cNvPr id="11" name="TextBox 15"/>
          <p:cNvSpPr txBox="1"/>
          <p:nvPr/>
        </p:nvSpPr>
        <p:spPr>
          <a:xfrm>
            <a:off x="2076345" y="3830246"/>
            <a:ext cx="8438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400bp</a:t>
            </a:r>
            <a:endParaRPr 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076346" y="3727851"/>
            <a:ext cx="924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500bp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2076346" y="3574259"/>
            <a:ext cx="9240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600bp</a:t>
            </a:r>
            <a:endParaRPr 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066790" y="2857496"/>
            <a:ext cx="857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1.5 kb</a:t>
            </a:r>
            <a:endParaRPr lang="en-US" sz="1400" b="1" dirty="0"/>
          </a:p>
        </p:txBody>
      </p:sp>
      <p:pic>
        <p:nvPicPr>
          <p:cNvPr id="7" name="Picture 2" descr="D:\PhD\phd\Mr. SS\gel doc files\HP 2018-11-28 12hr 00min 129e1 gDNA PCR KF bulls 6332 6479 6555 6568 7141 7178 7205 used for gel extraction.jpg"/>
          <p:cNvPicPr>
            <a:picLocks noChangeAspect="1" noChangeArrowheads="1"/>
          </p:cNvPicPr>
          <p:nvPr/>
        </p:nvPicPr>
        <p:blipFill>
          <a:blip r:embed="rId3"/>
          <a:srcRect l="9733" t="-39" r="9060" b="-1941"/>
          <a:stretch>
            <a:fillRect/>
          </a:stretch>
        </p:blipFill>
        <p:spPr bwMode="auto">
          <a:xfrm>
            <a:off x="2757154" y="714332"/>
            <a:ext cx="4958118" cy="6143668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3150970" y="841476"/>
            <a:ext cx="519449" cy="220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100bp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238892" y="835187"/>
            <a:ext cx="534128" cy="220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LF2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730581" y="835187"/>
            <a:ext cx="534128" cy="220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LF3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07720" y="835187"/>
            <a:ext cx="534128" cy="220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LF4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720628" y="835187"/>
            <a:ext cx="534128" cy="220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LF5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155328" y="819402"/>
            <a:ext cx="534128" cy="220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LF6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761753" y="850972"/>
            <a:ext cx="534128" cy="2205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solidFill>
                  <a:schemeClr val="bg1"/>
                </a:solidFill>
              </a:rPr>
              <a:t>LF1</a:t>
            </a:r>
            <a:endParaRPr lang="en-US" sz="1400" b="1" dirty="0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066790" y="3148896"/>
            <a:ext cx="857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1 kb</a:t>
            </a:r>
            <a:endParaRPr lang="en-US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14282" y="214290"/>
            <a:ext cx="971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Figure 5C</a:t>
            </a:r>
            <a:endParaRPr lang="en-US" sz="16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40</Words>
  <Application>Microsoft Office PowerPoint</Application>
  <PresentationFormat>On-screen Show (4:3)</PresentationFormat>
  <Paragraphs>81</Paragraphs>
  <Slides>5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ll</dc:creator>
  <cp:lastModifiedBy>dell</cp:lastModifiedBy>
  <cp:revision>3</cp:revision>
  <dcterms:created xsi:type="dcterms:W3CDTF">2022-06-27T15:13:20Z</dcterms:created>
  <dcterms:modified xsi:type="dcterms:W3CDTF">2022-06-28T11:44:26Z</dcterms:modified>
</cp:coreProperties>
</file>